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50F0E3-56E6-413E-8947-42F823B2A12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AEE47B-5827-48ED-BB02-E6359F84BF0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A2CFB-03C1-46BB-8906-EB271B5071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628E9-A172-44E7-BE74-F975AD4456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E858B-8B28-4A8B-A3F9-8BC43B7E15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47602-73A4-40E1-A49E-35AEE93498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F4CB9-57BC-40F2-AA79-FB393B6426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DE7E7-3056-4B78-87FC-E0B8017A2C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E54BB-A4DE-45C5-BD2C-A0501C774F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B18A5-BB96-4B42-978C-53D9F876C9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7FCF4-B8AB-45A1-B636-0CE20E8013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44F01-5F0F-4435-9C4C-8FA1E6BC36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6AE0B-58BE-4A29-8BD7-7C454EE2B4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A62C3-A3B3-4F60-9015-D08C7EB3A5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61C1B3-B884-4A82-8C8E-4BCBB25747A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9"/>
          <p:cNvSpPr/>
          <p:nvPr/>
        </p:nvSpPr>
        <p:spPr>
          <a:xfrm>
            <a:off x="0" y="274680"/>
            <a:ext cx="49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"/>
          <p:cNvSpPr/>
          <p:nvPr/>
        </p:nvSpPr>
        <p:spPr>
          <a:xfrm>
            <a:off x="0" y="3699000"/>
            <a:ext cx="5200560" cy="277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Death Receptor Expression Levels in 089 and 090 Cell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A,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 089 and 090 cells were treated with 2.5 ng/ml Bortezomib (Btz) for 20 hours. The surface expression of TRAIL receptors was assessed by flow cytometry following staining with monoclonal antibodies for TRAIL-R1 (DR4), TRAIL-R2 (DR5) or a mouse isotype control and a secondary anti-mouse FITC-coupled antibody. Representative FITC histograms of isotype controls (shaded area), basal DR expression (solid line) or Bortezomib-induced DR expression (dotted line) from 3 independent experiments are show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Group 5"/>
          <p:cNvGrpSpPr/>
          <p:nvPr/>
        </p:nvGrpSpPr>
        <p:grpSpPr>
          <a:xfrm>
            <a:off x="409680" y="418680"/>
            <a:ext cx="2855880" cy="2928600"/>
            <a:chOff x="409680" y="418680"/>
            <a:chExt cx="2855880" cy="2928600"/>
          </a:xfrm>
        </p:grpSpPr>
        <p:pic>
          <p:nvPicPr>
            <p:cNvPr id="51" name="Picture 6" descr=""/>
            <p:cNvPicPr/>
            <p:nvPr/>
          </p:nvPicPr>
          <p:blipFill>
            <a:blip r:embed="rId1"/>
            <a:srcRect l="4140" t="6789" r="74322" b="33751"/>
            <a:stretch/>
          </p:blipFill>
          <p:spPr>
            <a:xfrm>
              <a:off x="948600" y="572760"/>
              <a:ext cx="1152000" cy="115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7" descr=""/>
            <p:cNvPicPr/>
            <p:nvPr/>
          </p:nvPicPr>
          <p:blipFill>
            <a:blip r:embed="rId2"/>
            <a:srcRect l="28717" t="6789" r="49746" b="33751"/>
            <a:stretch/>
          </p:blipFill>
          <p:spPr>
            <a:xfrm>
              <a:off x="934200" y="1741680"/>
              <a:ext cx="1152000" cy="115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8" descr=""/>
            <p:cNvPicPr/>
            <p:nvPr/>
          </p:nvPicPr>
          <p:blipFill>
            <a:blip r:embed="rId3"/>
            <a:srcRect l="52809" t="6789" r="25653" b="33751"/>
            <a:stretch/>
          </p:blipFill>
          <p:spPr>
            <a:xfrm>
              <a:off x="2113560" y="565200"/>
              <a:ext cx="1152000" cy="115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0" descr=""/>
            <p:cNvPicPr/>
            <p:nvPr/>
          </p:nvPicPr>
          <p:blipFill>
            <a:blip r:embed="rId4"/>
            <a:srcRect l="76585" t="6789" r="1877" b="33751"/>
            <a:stretch/>
          </p:blipFill>
          <p:spPr>
            <a:xfrm>
              <a:off x="2050920" y="1727280"/>
              <a:ext cx="1152000" cy="115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Box 11"/>
            <p:cNvSpPr/>
            <p:nvPr/>
          </p:nvSpPr>
          <p:spPr>
            <a:xfrm>
              <a:off x="811080" y="2874600"/>
              <a:ext cx="132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08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2"/>
            <p:cNvSpPr/>
            <p:nvPr/>
          </p:nvSpPr>
          <p:spPr>
            <a:xfrm>
              <a:off x="1942560" y="2897280"/>
              <a:ext cx="132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09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3"/>
            <p:cNvSpPr/>
            <p:nvPr/>
          </p:nvSpPr>
          <p:spPr>
            <a:xfrm rot="16200000">
              <a:off x="157680" y="2115720"/>
              <a:ext cx="132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TRAIL-R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4"/>
            <p:cNvSpPr/>
            <p:nvPr/>
          </p:nvSpPr>
          <p:spPr>
            <a:xfrm rot="16200000">
              <a:off x="157680" y="949320"/>
              <a:ext cx="132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TRAIL-R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9" name="Straight Arrow Connector 15"/>
            <p:cNvCxnSpPr/>
            <p:nvPr/>
          </p:nvCxnSpPr>
          <p:spPr>
            <a:xfrm flipV="1">
              <a:off x="572400" y="812160"/>
              <a:ext cx="1080" cy="24170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0" name="Straight Arrow Connector 16"/>
            <p:cNvCxnSpPr/>
            <p:nvPr/>
          </p:nvCxnSpPr>
          <p:spPr>
            <a:xfrm>
              <a:off x="564480" y="3228840"/>
              <a:ext cx="238860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1" name="TextBox 17"/>
            <p:cNvSpPr/>
            <p:nvPr/>
          </p:nvSpPr>
          <p:spPr>
            <a:xfrm>
              <a:off x="1117800" y="3085920"/>
              <a:ext cx="119448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Intensity FIT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8"/>
            <p:cNvSpPr/>
            <p:nvPr/>
          </p:nvSpPr>
          <p:spPr>
            <a:xfrm rot="16200000">
              <a:off x="75600" y="1869480"/>
              <a:ext cx="92916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1100" spc="-1" strike="noStrike">
                  <a:solidFill>
                    <a:srgbClr val="000000"/>
                  </a:solidFill>
                  <a:latin typeface="Arial"/>
                  <a:ea typeface="Tahoma"/>
                </a:rPr>
                <a:t>Cell Count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TextBox 19"/>
          <p:cNvSpPr/>
          <p:nvPr/>
        </p:nvSpPr>
        <p:spPr>
          <a:xfrm>
            <a:off x="3703680" y="1081080"/>
            <a:ext cx="132228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sotype 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+ 2.5 ng/ml Btz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20"/>
          <p:cNvSpPr/>
          <p:nvPr/>
        </p:nvSpPr>
        <p:spPr>
          <a:xfrm>
            <a:off x="3382920" y="1303200"/>
            <a:ext cx="360360" cy="0"/>
          </a:xfrm>
          <a:prstGeom prst="line">
            <a:avLst/>
          </a:prstGeom>
          <a:ln w="1260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Straight Connector 21"/>
          <p:cNvSpPr/>
          <p:nvPr/>
        </p:nvSpPr>
        <p:spPr>
          <a:xfrm>
            <a:off x="3382920" y="18464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traight Connector 22"/>
          <p:cNvSpPr/>
          <p:nvPr/>
        </p:nvSpPr>
        <p:spPr>
          <a:xfrm>
            <a:off x="3382920" y="15746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04T12:38:45Z</dcterms:created>
  <dc:creator>Jessica</dc:creator>
  <dc:description/>
  <dc:language>en-US</dc:language>
  <cp:lastModifiedBy>mn.nandini</cp:lastModifiedBy>
  <dcterms:modified xsi:type="dcterms:W3CDTF">2014-10-16T09:17:20Z</dcterms:modified>
  <cp:revision>7</cp:revision>
  <dc:subject/>
  <dc:title>PowerPoint Presentation</dc:title>
</cp:coreProperties>
</file>